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C77534-154A-4FFD-89FA-39EC1F86E1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8CBBE-014E-44A7-B080-781C0161F5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D458C-F548-4D3B-8417-F2FB3AE2E0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470E9-1322-44A9-90C4-181DB62EAE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80149F-BE15-416C-8976-DF54C34E3B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974DDE-A65F-4F0D-A2E6-29EA68AE07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84C56-9DA4-42DC-88CA-BD22DCAA0D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6C630-F16A-4B1B-BBB3-4664695EAB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ADE61-531E-4FB1-80B9-020E654262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BAA1F-6D04-4E9F-AD0E-508645CCBC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8E124-0287-4CB4-8870-C089D41294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2A427-DBAF-4C01-9984-05CF81A6EA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7C4E70-45B3-4B9C-A44D-B33B4A7FEA03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235160" y="449280"/>
            <a:ext cx="5310000" cy="39830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1214280" y="4822920"/>
            <a:ext cx="5667480" cy="424980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5"/>
          <p:cNvSpPr/>
          <p:nvPr/>
        </p:nvSpPr>
        <p:spPr>
          <a:xfrm>
            <a:off x="4521240" y="1482840"/>
            <a:ext cx="1928880" cy="7855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4775040" y="5983200"/>
            <a:ext cx="1928880" cy="785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7"/>
          <p:cNvSpPr/>
          <p:nvPr/>
        </p:nvSpPr>
        <p:spPr>
          <a:xfrm>
            <a:off x="285840" y="120600"/>
            <a:ext cx="235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</a:rPr>
              <a:t>Supplemental 1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8"/>
          <p:cNvSpPr/>
          <p:nvPr/>
        </p:nvSpPr>
        <p:spPr>
          <a:xfrm>
            <a:off x="4429080" y="6000840"/>
            <a:ext cx="200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Logrank p=0.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9"/>
          <p:cNvSpPr/>
          <p:nvPr/>
        </p:nvSpPr>
        <p:spPr>
          <a:xfrm>
            <a:off x="4429080" y="1643040"/>
            <a:ext cx="200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Logrank p=0.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10"/>
          <p:cNvSpPr/>
          <p:nvPr/>
        </p:nvSpPr>
        <p:spPr>
          <a:xfrm>
            <a:off x="2714760" y="4978440"/>
            <a:ext cx="235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</a:rPr>
              <a:t>Anthracycli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ZoneTexte 11"/>
          <p:cNvSpPr/>
          <p:nvPr/>
        </p:nvSpPr>
        <p:spPr>
          <a:xfrm>
            <a:off x="2714760" y="285840"/>
            <a:ext cx="235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</a:rPr>
              <a:t>Taxane-Trastuzum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2"/>
          <p:cNvSpPr/>
          <p:nvPr/>
        </p:nvSpPr>
        <p:spPr>
          <a:xfrm>
            <a:off x="1204920" y="3681360"/>
            <a:ext cx="571320" cy="1429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3"/>
          <p:cNvSpPr/>
          <p:nvPr/>
        </p:nvSpPr>
        <p:spPr>
          <a:xfrm>
            <a:off x="1252440" y="3981600"/>
            <a:ext cx="571680" cy="1425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4"/>
          <p:cNvSpPr/>
          <p:nvPr/>
        </p:nvSpPr>
        <p:spPr>
          <a:xfrm>
            <a:off x="1233360" y="8267760"/>
            <a:ext cx="571680" cy="1429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5"/>
          <p:cNvSpPr/>
          <p:nvPr/>
        </p:nvSpPr>
        <p:spPr>
          <a:xfrm>
            <a:off x="1243080" y="8596440"/>
            <a:ext cx="571320" cy="1429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onnecteur droit 17"/>
          <p:cNvSpPr/>
          <p:nvPr/>
        </p:nvSpPr>
        <p:spPr>
          <a:xfrm>
            <a:off x="571680" y="4214880"/>
            <a:ext cx="357120" cy="1440"/>
          </a:xfrm>
          <a:prstGeom prst="line">
            <a:avLst/>
          </a:prstGeom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onnecteur droit 19"/>
          <p:cNvSpPr/>
          <p:nvPr/>
        </p:nvSpPr>
        <p:spPr>
          <a:xfrm>
            <a:off x="571680" y="3927600"/>
            <a:ext cx="357120" cy="1440"/>
          </a:xfrm>
          <a:prstGeom prst="line">
            <a:avLst/>
          </a:prstGeom>
          <a:ln w="2844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ZoneTexte 22"/>
          <p:cNvSpPr/>
          <p:nvPr/>
        </p:nvSpPr>
        <p:spPr>
          <a:xfrm>
            <a:off x="919080" y="375300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Non 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ZoneTexte 23"/>
          <p:cNvSpPr/>
          <p:nvPr/>
        </p:nvSpPr>
        <p:spPr>
          <a:xfrm>
            <a:off x="890640" y="4052880"/>
            <a:ext cx="75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onnecteur droit 24"/>
          <p:cNvSpPr/>
          <p:nvPr/>
        </p:nvSpPr>
        <p:spPr>
          <a:xfrm>
            <a:off x="714240" y="8825040"/>
            <a:ext cx="357480" cy="1440"/>
          </a:xfrm>
          <a:prstGeom prst="line">
            <a:avLst/>
          </a:prstGeom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onnecteur droit 25"/>
          <p:cNvSpPr/>
          <p:nvPr/>
        </p:nvSpPr>
        <p:spPr>
          <a:xfrm>
            <a:off x="714240" y="8537400"/>
            <a:ext cx="357480" cy="1800"/>
          </a:xfrm>
          <a:prstGeom prst="line">
            <a:avLst/>
          </a:prstGeom>
          <a:ln w="2844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ZoneTexte 26"/>
          <p:cNvSpPr/>
          <p:nvPr/>
        </p:nvSpPr>
        <p:spPr>
          <a:xfrm>
            <a:off x="1042920" y="836280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Non 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ZoneTexte 27"/>
          <p:cNvSpPr/>
          <p:nvPr/>
        </p:nvSpPr>
        <p:spPr>
          <a:xfrm>
            <a:off x="1033560" y="8663040"/>
            <a:ext cx="75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3T14:14:15Z</dcterms:created>
  <dc:creator>Utilisateur Windows</dc:creator>
  <dc:description/>
  <dc:language>en-US</dc:language>
  <cp:lastModifiedBy>fghiringhelli</cp:lastModifiedBy>
  <dcterms:modified xsi:type="dcterms:W3CDTF">2011-06-04T18:30:52Z</dcterms:modified>
  <cp:revision>3</cp:revision>
  <dc:subject/>
  <dc:title>Diapositive 1</dc:title>
</cp:coreProperties>
</file>